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840"/>
  </p:normalViewPr>
  <p:slideViewPr>
    <p:cSldViewPr snapToGrid="0">
      <p:cViewPr varScale="1">
        <p:scale>
          <a:sx n="90" d="100"/>
          <a:sy n="90" d="100"/>
        </p:scale>
        <p:origin x="232" y="6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594E2A-982A-FB3A-85A0-487C6DEE21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467FBFD-33DF-43DC-097D-804BDAA094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2492AF-B6FB-13B4-FF21-8718632693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73BB7B-573E-70C1-8B85-9F17CE6E4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AFFBB1-6C39-2421-FA3B-467883016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4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FAAEC6-4BF2-D06F-9DFD-2C8C088CC7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992DE4-DB92-FA1C-B5E7-0F11E47F79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BAE19D-729E-CC86-F2CE-F78028B92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2FDE4F-12C6-9106-22BF-5FB774DA4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C09DF4-A5DC-729E-C68F-4C25D916E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741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7DD481-8947-B756-C284-4793FBB13D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BAB525-C6FA-F5A0-E527-7AEE4517D1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04A515-76F7-0E5A-8341-BAE421691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939C67-25BE-9B0F-1471-F93E1A35F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90391E-8AA2-CA67-B723-2AB40B423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094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F9451A-16E3-AAEC-9181-C7685E4FA0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E11553-5000-BDC8-DD4F-C90FB81B17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A303A5-8BA6-0D47-D9C4-64FAFCBE1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A4EA34-DAB7-2DE1-2E81-1259BC5C3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3B0023-F315-653A-B0B9-04F6D38F9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939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C2BD65-7460-783B-FD00-3BD279406A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3F3AF4-2A88-667A-8FAB-7AD7F443D9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B63FB7-2A60-A9C9-7768-99CC315BC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9890D3-1614-F5DF-2065-E4C209C88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63FDF9-233F-47E4-69A0-5F2B9480A0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328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8AAE34-F237-3FAE-BD70-FC9DFB6CF8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00935C-4006-2A67-6DED-43FFCDD015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1E2580-D78D-528F-93AE-63C43FA28E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526901-9329-1A0A-2F55-02789B506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151A0C-D6D3-745F-FD87-AFB934662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5CFDCB-6AE8-1595-A074-346EBF33B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165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1DDBA-C366-DE2B-D79B-8060D85520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98EC97-B7EB-DCC8-CE28-2ADF616861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CE90B1-19C1-CA88-F594-F4278BEA40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3A47E1-3DD7-2CFF-E6CA-86BD711F9C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E678621-ADB8-AF4E-5992-07C0BB0883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716860C-BA06-7A76-84BB-1E3D135CE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F5EA61-ED5D-0D66-14FE-2813768381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8C9A55-C807-EF13-71E5-642C5E65C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634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88A4AD-01FE-2FCE-5A04-CFDC27B859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05E60D-FE03-78E8-0730-E72DCEB59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1284976-3989-C0D7-C186-9C78552A3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92D5C3A-AB87-C75A-617B-93ECA88195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883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D74B8E-B79B-3AC7-5C17-45F0E3F89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B270F59-DA13-B33D-D9DB-8DE97504F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E5D38B-0AC6-8DB5-43E6-CBEE14D56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30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3B8E36-7D55-B72E-C522-E08F5AB35C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B236EF-A203-AEC7-267D-43FE1E3579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1D4E2E-D594-6934-1D96-732DBD58BB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25C014-D702-3266-F9FC-B09F817E2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60C7C1-EBE2-1CA4-9D70-BC16C84632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9AF4CA-A9CD-C908-3AC0-FCA0168B93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33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F33AC0-1D07-A2D3-C940-C21777429A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80A59C-70F5-150A-5E3C-A625D2FA22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AF6A04-EEC9-BA81-3BE4-4E5E86EEEE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EBF682-8065-4D1D-6034-203FAC54A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696C8B-D28D-388A-B5D9-643E28319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9DE7D1-F03D-D051-CCA5-5AC249CB8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576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A0FC064-05F6-41FE-B13C-B253A2458A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B00483-4B67-8F12-1862-06FFD66289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D73E3B-F4FD-3BEC-B402-60EC97568B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1A52E-7591-7F43-834F-4BD2BD202847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DC89AE-33F5-A5C2-9A12-C3683589D4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B6A2ED-022A-88FC-C85E-32BA458A07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EE300-1E3D-3549-BF87-A04AB991F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417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79191C7A-779A-4CD7-012E-6DCD47EC665D}"/>
              </a:ext>
            </a:extLst>
          </p:cNvPr>
          <p:cNvSpPr txBox="1"/>
          <p:nvPr/>
        </p:nvSpPr>
        <p:spPr>
          <a:xfrm>
            <a:off x="0" y="0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/>
              <a:t>Figure S5: </a:t>
            </a:r>
            <a:r>
              <a:rPr lang="en-US" dirty="0"/>
              <a:t>Variability in Fractional Anisotropy (FA) values calculated between two sessions for each scanner calculated as 100* (test-retest)/mean(test, retest)</a:t>
            </a:r>
          </a:p>
        </p:txBody>
      </p:sp>
      <p:pic>
        <p:nvPicPr>
          <p:cNvPr id="3" name="Picture 2" descr="A screen shot of a computer screen&#10;&#10;Description automatically generated">
            <a:extLst>
              <a:ext uri="{FF2B5EF4-FFF2-40B4-BE49-F238E27FC236}">
                <a16:creationId xmlns:a16="http://schemas.microsoft.com/office/drawing/2014/main" id="{14925899-202D-D83B-253D-73151460E6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3459" y="646331"/>
            <a:ext cx="9759315" cy="61742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2618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1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jiha Bano</dc:creator>
  <cp:lastModifiedBy>Wajiha Bano</cp:lastModifiedBy>
  <cp:revision>2</cp:revision>
  <dcterms:created xsi:type="dcterms:W3CDTF">2023-05-06T07:04:05Z</dcterms:created>
  <dcterms:modified xsi:type="dcterms:W3CDTF">2024-02-20T20:15:51Z</dcterms:modified>
</cp:coreProperties>
</file>